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E1543-24AC-46C6-9C07-20DFB2DC80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44C1F5-E6EB-4800-A8F5-A4192F3D45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209E1E-FDAE-41E2-8D8A-D1F91D2FA4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62516-5790-4609-8CEB-D1625E880F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CE90B-E84D-42E5-975F-77C37ACB0B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BC6A2F-1A0E-44E4-9B16-2B2F33625A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BC3E1E-AED1-403F-A403-3B82F701F0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E755FC-F578-42F0-BB9C-156000EA19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9FCEF8-97A7-4E7F-A591-3F613870E8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880ED-8155-47DD-993D-675610BC7F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08A3C6-89C9-4BF9-A7FF-1269A2A3E5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8EE93-AC5E-495F-979F-9A83AA3D1C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2586EC-AE39-467C-89A1-7E7DF4EBFC7A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80880" y="457200"/>
            <a:ext cx="8001000" cy="34448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28600" y="4038480"/>
            <a:ext cx="86104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Times New Roman"/>
              </a:rPr>
              <a:t>Figure S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zh-CN" sz="1800" spc="-1" strike="noStrike">
                <a:solidFill>
                  <a:srgbClr val="000000"/>
                </a:solidFill>
                <a:latin typeface="Times New Roman"/>
              </a:rPr>
              <a:t>NF</a:t>
            </a:r>
            <a:r>
              <a:rPr b="0" i="1" lang="el-GR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κ</a:t>
            </a:r>
            <a:r>
              <a:rPr b="0" i="1" lang="zh-CN" sz="1800" spc="-1" strike="noStrike">
                <a:solidFill>
                  <a:srgbClr val="000000"/>
                </a:solidFill>
                <a:latin typeface="Times New Roman"/>
              </a:rPr>
              <a:t>-94ins/delATTG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genotyping by direct sequencing:    (a) </a:t>
            </a:r>
            <a:r>
              <a:rPr b="0" i="1" lang="zh-CN" sz="1800" spc="-1" strike="noStrike">
                <a:solidFill>
                  <a:srgbClr val="000000"/>
                </a:solidFill>
                <a:latin typeface="Times New Roman"/>
              </a:rPr>
              <a:t>del/del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genotype; (b) </a:t>
            </a:r>
            <a:r>
              <a:rPr b="0" i="1" lang="zh-CN" sz="1800" spc="-1" strike="noStrike">
                <a:solidFill>
                  <a:srgbClr val="000000"/>
                </a:solidFill>
                <a:latin typeface="Times New Roman"/>
              </a:rPr>
              <a:t>del/ins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genotype; (c)</a:t>
            </a:r>
            <a:r>
              <a:rPr b="0" i="1" lang="zh-CN" sz="1800" spc="-1" strike="noStrike">
                <a:solidFill>
                  <a:srgbClr val="000000"/>
                </a:solidFill>
                <a:latin typeface="Times New Roman"/>
              </a:rPr>
              <a:t> ins/ins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 genotype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雨林木风</cp:lastModifiedBy>
  <dcterms:modified xsi:type="dcterms:W3CDTF">2011-06-12T15:46:12Z</dcterms:modified>
  <cp:revision>1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